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6" r:id="rId5"/>
    <p:sldId id="25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9.xlsx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7.xlsx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8.xlsx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1'!$H$2:$H$4</c:f>
              <c:numCache>
                <c:formatCode>General</c:formatCode>
                <c:ptCount val="3"/>
                <c:pt idx="0">
                  <c:v>17.138908085694524</c:v>
                </c:pt>
                <c:pt idx="1">
                  <c:v>47.325501036627507</c:v>
                </c:pt>
                <c:pt idx="2">
                  <c:v>38.935729094678642</c:v>
                </c:pt>
              </c:numCache>
            </c:numRef>
          </c:xVal>
          <c:yVal>
            <c:numRef>
              <c:f>'E1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E02-4E0F-93D5-EEB6AA1A2C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1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12'!$H$2:$H$4</c:f>
              <c:numCache>
                <c:formatCode>General</c:formatCode>
                <c:ptCount val="3"/>
                <c:pt idx="0">
                  <c:v>12.624584717607974</c:v>
                </c:pt>
                <c:pt idx="1">
                  <c:v>19.401993355481721</c:v>
                </c:pt>
                <c:pt idx="2">
                  <c:v>32.823920265780743</c:v>
                </c:pt>
              </c:numCache>
            </c:numRef>
          </c:xVal>
          <c:yVal>
            <c:numRef>
              <c:f>'E12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79C-4F2E-A1B6-F0E7CFAB64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2'!$H$2:$H$4</c:f>
              <c:numCache>
                <c:formatCode>General</c:formatCode>
                <c:ptCount val="3"/>
                <c:pt idx="0">
                  <c:v>26.460239268121043</c:v>
                </c:pt>
                <c:pt idx="1">
                  <c:v>42.843068261787479</c:v>
                </c:pt>
                <c:pt idx="2">
                  <c:v>39.232934553131606</c:v>
                </c:pt>
              </c:numCache>
            </c:numRef>
          </c:xVal>
          <c:yVal>
            <c:numRef>
              <c:f>'E2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0DD-46A5-8E41-F1237031C7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4'!$H$2:$H$4</c:f>
              <c:numCache>
                <c:formatCode>General</c:formatCode>
                <c:ptCount val="3"/>
                <c:pt idx="0">
                  <c:v>23.574947220267418</c:v>
                </c:pt>
                <c:pt idx="1">
                  <c:v>39.753694581280783</c:v>
                </c:pt>
                <c:pt idx="2">
                  <c:v>31.315974665728362</c:v>
                </c:pt>
              </c:numCache>
            </c:numRef>
          </c:xVal>
          <c:yVal>
            <c:numRef>
              <c:f>'E4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475-42E7-882A-6BFDD5D294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6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351162790697674"/>
          <c:y val="0.25714292929292931"/>
          <c:w val="0.75086434108527134"/>
          <c:h val="0.47729040404040401"/>
        </c:manualLayout>
      </c:layout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6'!$H$2:$H$4</c:f>
              <c:numCache>
                <c:formatCode>General</c:formatCode>
                <c:ptCount val="3"/>
                <c:pt idx="0">
                  <c:v>18.296973961998603</c:v>
                </c:pt>
                <c:pt idx="1">
                  <c:v>21.885995777621389</c:v>
                </c:pt>
                <c:pt idx="2">
                  <c:v>12.526389866291339</c:v>
                </c:pt>
              </c:numCache>
            </c:numRef>
          </c:xVal>
          <c:yVal>
            <c:numRef>
              <c:f>'E6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89A-4DEA-BF13-8088C92816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7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7'!$H$2:$H$4</c:f>
              <c:numCache>
                <c:formatCode>General</c:formatCode>
                <c:ptCount val="3"/>
                <c:pt idx="0">
                  <c:v>-1.8712574850299433</c:v>
                </c:pt>
                <c:pt idx="1">
                  <c:v>21.107784431137716</c:v>
                </c:pt>
                <c:pt idx="2">
                  <c:v>28.899700598802397</c:v>
                </c:pt>
              </c:numCache>
            </c:numRef>
          </c:xVal>
          <c:yVal>
            <c:numRef>
              <c:f>'E7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8A68-42FC-ADB0-83E9E7CA2F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382979215365113"/>
          <c:y val="0.21839806557974778"/>
          <c:w val="0.83426535428617676"/>
          <c:h val="0.49279052079188124"/>
        </c:manualLayout>
      </c:layout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8'!$H$2:$H$4</c:f>
              <c:numCache>
                <c:formatCode>General</c:formatCode>
                <c:ptCount val="3"/>
                <c:pt idx="0">
                  <c:v>-24.700598802395206</c:v>
                </c:pt>
                <c:pt idx="1">
                  <c:v>6.5868263473053901</c:v>
                </c:pt>
                <c:pt idx="2">
                  <c:v>15.643712574850298</c:v>
                </c:pt>
              </c:numCache>
            </c:numRef>
          </c:xVal>
          <c:yVal>
            <c:numRef>
              <c:f>'E8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9ED-4292-8FFA-746AD9DD71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9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9'!$H$2:$H$4</c:f>
              <c:numCache>
                <c:formatCode>General</c:formatCode>
                <c:ptCount val="3"/>
                <c:pt idx="0">
                  <c:v>32.754491017964071</c:v>
                </c:pt>
                <c:pt idx="1">
                  <c:v>5.2395209580838298</c:v>
                </c:pt>
                <c:pt idx="2">
                  <c:v>8.682634730538922</c:v>
                </c:pt>
              </c:numCache>
            </c:numRef>
          </c:xVal>
          <c:yVal>
            <c:numRef>
              <c:f>'E9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0FC-4DFF-BFE9-2D2AFDF737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10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10'!$H$2:$H$4</c:f>
              <c:numCache>
                <c:formatCode>General</c:formatCode>
                <c:ptCount val="3"/>
                <c:pt idx="0">
                  <c:v>45.306886227544915</c:v>
                </c:pt>
                <c:pt idx="1">
                  <c:v>45.082335329341319</c:v>
                </c:pt>
                <c:pt idx="2">
                  <c:v>42.035928143712574</c:v>
                </c:pt>
              </c:numCache>
            </c:numRef>
          </c:xVal>
          <c:yVal>
            <c:numRef>
              <c:f>'E10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3FF9-4AA9-AB41-E32BD094589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dirty="0"/>
              <a:t>E1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v>E1</c:v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1"/>
            <c:trendlineLbl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E11'!$H$2:$H$4</c:f>
              <c:numCache>
                <c:formatCode>General</c:formatCode>
                <c:ptCount val="3"/>
                <c:pt idx="0">
                  <c:v>5.9800664451827146</c:v>
                </c:pt>
                <c:pt idx="1">
                  <c:v>22.99003322259135</c:v>
                </c:pt>
                <c:pt idx="2">
                  <c:v>33.767441860465112</c:v>
                </c:pt>
              </c:numCache>
            </c:numRef>
          </c:xVal>
          <c:yVal>
            <c:numRef>
              <c:f>'E11'!$A$2:$A$4</c:f>
              <c:numCache>
                <c:formatCode>General</c:formatCode>
                <c:ptCount val="3"/>
                <c:pt idx="0">
                  <c:v>3.75</c:v>
                </c:pt>
                <c:pt idx="1">
                  <c:v>18.75</c:v>
                </c:pt>
                <c:pt idx="2">
                  <c:v>3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381-4192-B195-8706CA0AA7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69956592"/>
        <c:axId val="1597848080"/>
      </c:scatterChart>
      <c:valAx>
        <c:axId val="146995659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CAA Unit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597848080"/>
        <c:crosses val="autoZero"/>
        <c:crossBetween val="midCat"/>
      </c:valAx>
      <c:valAx>
        <c:axId val="1597848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/>
                  <a:t>mg/L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6995659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644B84-3C84-B14A-43B4-E8F2BAEBAA9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C4B044A-535F-65F0-9C05-09748406D8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171FB8-63F2-4580-C281-837D1E8F0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C034A8-EF99-C0DF-0AEE-EB36270FA6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90C477-961E-4D6D-8D6A-F472BCEA3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7811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5C006D-E7F8-B5C6-CBEF-80F45EC196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48C9CA1-F7C1-95E1-C586-B686A50CBA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FF52D7-D44D-FCD4-F8C1-A07436E30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611382-B442-8E22-AD50-A154B25BE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7D44A1-DAF8-783F-AACB-726FE7907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4444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64B73A3-95C6-CE2A-EC32-3F3E64CC06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0793BD-2959-CE51-B20A-F012270E61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356C41-9580-6A96-7EE8-B6C03A18CB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8630F6-D9FD-9933-D2BB-91F87C688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EAA08A-D15F-43E3-C286-A713366FE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8131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DA1F36-8069-EBFD-B9F4-E86B8659BE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A0A4E8-D148-CBC8-C8D9-4E4C07F18D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E77653-80EB-BE2C-8607-0103AED2F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978FE5-AE13-AF8B-FC0D-5F942235F9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4DDEE0-C700-411A-A649-6103A11832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7720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3E1DC-B430-721D-4140-4048691E38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354B52-B74C-27BE-C776-8F90D64796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F59507-BB94-3061-B6E4-32E235106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1291DD-6F72-EBC4-6976-1F5F46318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7538A0-F053-E272-E451-221CAFD14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4926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42475D-F774-5F6A-C23D-8B59F1709E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EF352D-E8F6-13D1-39CF-7A8E8993DE2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49A256-F2ED-1F17-3B83-19B3974F67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2A2240-3276-CEAA-ECB6-89CF4E204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B0F826-AE8B-2B46-C7EB-44E4007BB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565C6F-69E3-01B7-7ED6-1259C42F0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8327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0DF0D-1CBB-98CD-C1D6-F046FCE4AF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93707A-B5E4-27CD-AFFF-9A3CCDC74F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0C564C-A90F-02F4-5451-164C076291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9C29CF-4099-D347-2F00-42A315C3A1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B1A74BC-616B-5E5E-3ACE-F172E45DBE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D06DC3E-5B25-44FB-4461-42DD7B1F2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6AD89F-2C84-2FF2-2073-96D54D2F5F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F0F4AA7-9554-A589-3235-B939AD0A9F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0049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0954CD-B9D7-F3CE-6DBC-5D12F1CF0B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03099A6-42BC-C2DF-71AB-55190390A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C67C3F6-71A1-D042-C596-55F8F68B4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1FCBDB-1238-60FC-F6EF-9B9D97ADD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5459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19D7752-B96F-5497-EB1F-3ADC5356F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920002-05BD-6B82-7177-1F17DC44B8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1FB88B-98E0-6DC6-925B-6FC826A3E8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9578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22ACBB-C7CF-7C0F-866C-3C522AF7CA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77A6D3-0A61-3E00-D02A-A241A36EED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12DB79-2ED9-7DC0-BCEE-F9E65024A5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D44D71-CFE6-FA45-EF57-91851DE5E0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DD794C-5732-DAC1-BA76-FDBAD03282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B4430B-567C-5A18-3E31-AB04A92D86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7146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5DD6CB-75D4-160D-D333-F4A48D3D0B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2E355D9-9611-C898-15EE-3D32EAFD7F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B8338F-F643-9A66-A6F2-ED10393D1E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AE92EC-FDBC-FB28-CD98-B5F601045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9E5F48-C8C3-50A5-6186-3B1E58BBD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48CFDE-4407-FA0D-B453-50203E06C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80251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9ED025-F4C0-747D-1A2D-D54DC71BE1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3858EC-8556-654D-970A-F18F33DDCE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FAF7B4-10E2-1D98-4470-DAC3FF98D5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612E8-9F33-4DA5-9337-BE3C83529B7C}" type="datetimeFigureOut">
              <a:rPr lang="en-GB" smtClean="0"/>
              <a:t>30/0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2D6D8B-39DE-C87F-6BF8-DAB2A081EF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B78FA4-A97E-8662-BA73-F513BC3A76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20EE9B-AD1C-4B5B-83A3-08807E1D92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6898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0401AE2-175E-45A0-9043-D7EADDA62331}"/>
              </a:ext>
            </a:extLst>
          </p:cNvPr>
          <p:cNvGrpSpPr/>
          <p:nvPr/>
        </p:nvGrpSpPr>
        <p:grpSpPr>
          <a:xfrm>
            <a:off x="2591171" y="1029006"/>
            <a:ext cx="5717957" cy="4013596"/>
            <a:chOff x="2294508" y="878085"/>
            <a:chExt cx="5717957" cy="4013597"/>
          </a:xfrm>
          <a:solidFill>
            <a:schemeClr val="bg1"/>
          </a:solidFill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4A2BE22-E6D6-42C0-A6B9-8407C521BDB5}"/>
                </a:ext>
              </a:extLst>
            </p:cNvPr>
            <p:cNvSpPr txBox="1"/>
            <p:nvPr/>
          </p:nvSpPr>
          <p:spPr>
            <a:xfrm>
              <a:off x="2294508" y="878085"/>
              <a:ext cx="5717957" cy="307905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pounds added in cells together with DCFH-DA</a:t>
              </a:r>
            </a:p>
          </p:txBody>
        </p: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EB521F8B-963D-4866-915F-9FE35833FA7E}"/>
                </a:ext>
              </a:extLst>
            </p:cNvPr>
            <p:cNvCxnSpPr/>
            <p:nvPr/>
          </p:nvCxnSpPr>
          <p:spPr>
            <a:xfrm>
              <a:off x="5069150" y="1353014"/>
              <a:ext cx="0" cy="857526"/>
            </a:xfrm>
            <a:prstGeom prst="straightConnector1">
              <a:avLst/>
            </a:prstGeom>
            <a:grpFill/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A3937EB-1D18-4E91-A890-86D58C4EF699}"/>
                </a:ext>
              </a:extLst>
            </p:cNvPr>
            <p:cNvSpPr txBox="1"/>
            <p:nvPr/>
          </p:nvSpPr>
          <p:spPr>
            <a:xfrm>
              <a:off x="3520735" y="2349511"/>
              <a:ext cx="3755253" cy="307905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GB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ash 2x with PBS, leave PBS in wells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9D0A4C1-A805-484B-99AB-B20833DDAE69}"/>
                </a:ext>
              </a:extLst>
            </p:cNvPr>
            <p:cNvSpPr txBox="1"/>
            <p:nvPr/>
          </p:nvSpPr>
          <p:spPr>
            <a:xfrm>
              <a:off x="5308846" y="1597111"/>
              <a:ext cx="1967145" cy="307905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GB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 hour incubation</a:t>
              </a:r>
            </a:p>
          </p:txBody>
        </p:sp>
        <p:cxnSp>
          <p:nvCxnSpPr>
            <p:cNvPr id="11" name="Straight Arrow Connector 10">
              <a:extLst>
                <a:ext uri="{FF2B5EF4-FFF2-40B4-BE49-F238E27FC236}">
                  <a16:creationId xmlns:a16="http://schemas.microsoft.com/office/drawing/2014/main" id="{0EA6E5D5-A61F-4E0F-8294-91DF6D688A06}"/>
                </a:ext>
              </a:extLst>
            </p:cNvPr>
            <p:cNvCxnSpPr/>
            <p:nvPr/>
          </p:nvCxnSpPr>
          <p:spPr>
            <a:xfrm>
              <a:off x="5069150" y="2816038"/>
              <a:ext cx="0" cy="857526"/>
            </a:xfrm>
            <a:prstGeom prst="straightConnector1">
              <a:avLst/>
            </a:prstGeom>
            <a:grpFill/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37B7234-75B9-4758-9C75-44F0C2EBE4AB}"/>
                </a:ext>
              </a:extLst>
            </p:cNvPr>
            <p:cNvSpPr txBox="1"/>
            <p:nvPr/>
          </p:nvSpPr>
          <p:spPr>
            <a:xfrm>
              <a:off x="3275859" y="3721490"/>
              <a:ext cx="3755253" cy="1170192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1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asure excitation 485 nm / emission 535 nm</a:t>
              </a:r>
            </a:p>
            <a:p>
              <a:pPr algn="ctr"/>
              <a:r>
                <a:rPr lang="en-GB" sz="140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0</a:t>
              </a:r>
            </a:p>
            <a:p>
              <a:pPr algn="ctr"/>
              <a:r>
                <a:rPr lang="en-GB" sz="140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10min</a:t>
              </a:r>
            </a:p>
            <a:p>
              <a:pPr algn="ctr"/>
              <a:r>
                <a:rPr lang="en-GB" sz="140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20min</a:t>
              </a:r>
            </a:p>
            <a:p>
              <a:pPr algn="ctr"/>
              <a:r>
                <a:rPr lang="en-GB" sz="140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me 60min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C6631186-EE1E-D4D5-0667-126D655CAEB9}"/>
              </a:ext>
            </a:extLst>
          </p:cNvPr>
          <p:cNvSpPr txBox="1"/>
          <p:nvPr/>
        </p:nvSpPr>
        <p:spPr>
          <a:xfrm>
            <a:off x="659167" y="5828994"/>
            <a:ext cx="1131681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b="1" dirty="0"/>
              <a:t>Supplementary Figure 1. Experimental design to measure inhibition of endogenous ROS levels by </a:t>
            </a:r>
            <a:r>
              <a:rPr lang="en-GB" b="1" i="1" dirty="0"/>
              <a:t>Vitis Vinifera </a:t>
            </a:r>
            <a:r>
              <a:rPr lang="en-GB" b="1" dirty="0"/>
              <a:t>extracts. </a:t>
            </a:r>
          </a:p>
        </p:txBody>
      </p:sp>
    </p:spTree>
    <p:extLst>
      <p:ext uri="{BB962C8B-B14F-4D97-AF65-F5344CB8AC3E}">
        <p14:creationId xmlns:p14="http://schemas.microsoft.com/office/powerpoint/2010/main" val="14717301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m 1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62871240"/>
              </p:ext>
            </p:extLst>
          </p:nvPr>
        </p:nvGraphicFramePr>
        <p:xfrm>
          <a:off x="-80655" y="40022"/>
          <a:ext cx="3096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Diagramm 3">
            <a:extLst>
              <a:ext uri="{FF2B5EF4-FFF2-40B4-BE49-F238E27FC236}">
                <a16:creationId xmlns:a16="http://schemas.microsoft.com/office/drawing/2014/main" id="{00000000-0008-0000-01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25112996"/>
              </p:ext>
            </p:extLst>
          </p:nvPr>
        </p:nvGraphicFramePr>
        <p:xfrm>
          <a:off x="2855852" y="76347"/>
          <a:ext cx="3096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Diagramm 3">
            <a:extLst>
              <a:ext uri="{FF2B5EF4-FFF2-40B4-BE49-F238E27FC236}">
                <a16:creationId xmlns:a16="http://schemas.microsoft.com/office/drawing/2014/main" id="{00000000-0008-0000-03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6145239"/>
              </p:ext>
            </p:extLst>
          </p:nvPr>
        </p:nvGraphicFramePr>
        <p:xfrm>
          <a:off x="5811988" y="81138"/>
          <a:ext cx="3293172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Diagramm 3">
            <a:extLst>
              <a:ext uri="{FF2B5EF4-FFF2-40B4-BE49-F238E27FC236}">
                <a16:creationId xmlns:a16="http://schemas.microsoft.com/office/drawing/2014/main" id="{00000000-0008-0000-04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7990735"/>
              </p:ext>
            </p:extLst>
          </p:nvPr>
        </p:nvGraphicFramePr>
        <p:xfrm>
          <a:off x="-146611" y="1759365"/>
          <a:ext cx="3096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Diagramm 3">
            <a:extLst>
              <a:ext uri="{FF2B5EF4-FFF2-40B4-BE49-F238E27FC236}">
                <a16:creationId xmlns:a16="http://schemas.microsoft.com/office/drawing/2014/main" id="{00000000-0008-0000-05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62228339"/>
              </p:ext>
            </p:extLst>
          </p:nvPr>
        </p:nvGraphicFramePr>
        <p:xfrm>
          <a:off x="3051418" y="1783548"/>
          <a:ext cx="3096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Diagramm 3">
            <a:extLst>
              <a:ext uri="{FF2B5EF4-FFF2-40B4-BE49-F238E27FC236}">
                <a16:creationId xmlns:a16="http://schemas.microsoft.com/office/drawing/2014/main" id="{00000000-0008-0000-06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5008193"/>
              </p:ext>
            </p:extLst>
          </p:nvPr>
        </p:nvGraphicFramePr>
        <p:xfrm>
          <a:off x="6011630" y="1759365"/>
          <a:ext cx="3200393" cy="20405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Diagramm 3">
            <a:extLst>
              <a:ext uri="{FF2B5EF4-FFF2-40B4-BE49-F238E27FC236}">
                <a16:creationId xmlns:a16="http://schemas.microsoft.com/office/drawing/2014/main" id="{00000000-0008-0000-07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37138144"/>
              </p:ext>
            </p:extLst>
          </p:nvPr>
        </p:nvGraphicFramePr>
        <p:xfrm>
          <a:off x="-97024" y="3699802"/>
          <a:ext cx="3096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Diagramm 3">
            <a:extLst>
              <a:ext uri="{FF2B5EF4-FFF2-40B4-BE49-F238E27FC236}">
                <a16:creationId xmlns:a16="http://schemas.microsoft.com/office/drawing/2014/main" id="{00000000-0008-0000-08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25042898"/>
              </p:ext>
            </p:extLst>
          </p:nvPr>
        </p:nvGraphicFramePr>
        <p:xfrm>
          <a:off x="2909593" y="3715532"/>
          <a:ext cx="3148876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Diagramm 3">
            <a:extLst>
              <a:ext uri="{FF2B5EF4-FFF2-40B4-BE49-F238E27FC236}">
                <a16:creationId xmlns:a16="http://schemas.microsoft.com/office/drawing/2014/main" id="{00000000-0008-0000-09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9748540"/>
              </p:ext>
            </p:extLst>
          </p:nvPr>
        </p:nvGraphicFramePr>
        <p:xfrm>
          <a:off x="5895607" y="3699802"/>
          <a:ext cx="3200393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B8BDBFEE-B914-1566-DC02-21F3D21FA6D4}"/>
              </a:ext>
            </a:extLst>
          </p:cNvPr>
          <p:cNvSpPr txBox="1"/>
          <p:nvPr/>
        </p:nvSpPr>
        <p:spPr>
          <a:xfrm>
            <a:off x="603682" y="5788241"/>
            <a:ext cx="109846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/>
              <a:t>Supplementary Figure 2. Graph showing CAA values of </a:t>
            </a:r>
            <a:r>
              <a:rPr lang="en-GB" b="1" i="1" dirty="0"/>
              <a:t>Vitis Vinifera </a:t>
            </a:r>
            <a:r>
              <a:rPr lang="en-GB" b="1" dirty="0"/>
              <a:t>extracts. </a:t>
            </a:r>
            <a:r>
              <a:rPr lang="en-GB" dirty="0"/>
              <a:t>The CAA units were calculated for each extract based on the dose response inhibition of ROS measured as emission at 535 nm and normalized to corresponding values of PBS. CAA; Cellular Antioxidant Activity.</a:t>
            </a:r>
          </a:p>
        </p:txBody>
      </p:sp>
      <p:graphicFrame>
        <p:nvGraphicFramePr>
          <p:cNvPr id="14" name="Diagramm 3">
            <a:extLst>
              <a:ext uri="{FF2B5EF4-FFF2-40B4-BE49-F238E27FC236}">
                <a16:creationId xmlns:a16="http://schemas.microsoft.com/office/drawing/2014/main" id="{00000000-0008-0000-0A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9990342"/>
              </p:ext>
            </p:extLst>
          </p:nvPr>
        </p:nvGraphicFramePr>
        <p:xfrm>
          <a:off x="8960212" y="3717398"/>
          <a:ext cx="3096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</p:spTree>
    <p:extLst>
      <p:ext uri="{BB962C8B-B14F-4D97-AF65-F5344CB8AC3E}">
        <p14:creationId xmlns:p14="http://schemas.microsoft.com/office/powerpoint/2010/main" val="7240704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62AFD4EA7B58C4CB01E4592B9199AF4" ma:contentTypeVersion="15" ma:contentTypeDescription="Create a new document." ma:contentTypeScope="" ma:versionID="9b08d7eae30527731bcdf2a9774fd6a3">
  <xsd:schema xmlns:xsd="http://www.w3.org/2001/XMLSchema" xmlns:xs="http://www.w3.org/2001/XMLSchema" xmlns:p="http://schemas.microsoft.com/office/2006/metadata/properties" xmlns:ns3="ecc27193-c6f9-4fb1-a80b-916327af78a7" xmlns:ns4="d849306f-2891-4c29-bb17-1cfb3af1d0c6" targetNamespace="http://schemas.microsoft.com/office/2006/metadata/properties" ma:root="true" ma:fieldsID="9b8316e0fcb8ff994f13d3853eff226a" ns3:_="" ns4:_="">
    <xsd:import namespace="ecc27193-c6f9-4fb1-a80b-916327af78a7"/>
    <xsd:import namespace="d849306f-2891-4c29-bb17-1cfb3af1d0c6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cc27193-c6f9-4fb1-a80b-916327af78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7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849306f-2891-4c29-bb17-1cfb3af1d0c6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ecc27193-c6f9-4fb1-a80b-916327af78a7" xsi:nil="true"/>
  </documentManagement>
</p:properties>
</file>

<file path=customXml/itemProps1.xml><?xml version="1.0" encoding="utf-8"?>
<ds:datastoreItem xmlns:ds="http://schemas.openxmlformats.org/officeDocument/2006/customXml" ds:itemID="{B38CA4B7-E480-45B1-8144-CC9D255942E3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3BDB273-A348-4216-8283-5869D96E649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ecc27193-c6f9-4fb1-a80b-916327af78a7"/>
    <ds:schemaRef ds:uri="d849306f-2891-4c29-bb17-1cfb3af1d0c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813CA6EB-F22D-4622-9B8B-18DB5C45BA0C}">
  <ds:schemaRefs>
    <ds:schemaRef ds:uri="http://purl.org/dc/terms/"/>
    <ds:schemaRef ds:uri="http://schemas.microsoft.com/office/infopath/2007/PartnerControls"/>
    <ds:schemaRef ds:uri="ecc27193-c6f9-4fb1-a80b-916327af78a7"/>
    <ds:schemaRef ds:uri="http://schemas.microsoft.com/office/2006/documentManagement/types"/>
    <ds:schemaRef ds:uri="http://schemas.microsoft.com/office/2006/metadata/properties"/>
    <ds:schemaRef ds:uri="http://purl.org/dc/elements/1.1/"/>
    <ds:schemaRef ds:uri="d849306f-2891-4c29-bb17-1cfb3af1d0c6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79</TotalTime>
  <Words>162</Words>
  <Application>Microsoft Office PowerPoint</Application>
  <PresentationFormat>Widescreen</PresentationFormat>
  <Paragraphs>4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a Neophytou</dc:creator>
  <cp:lastModifiedBy>Christiana Neophytou</cp:lastModifiedBy>
  <cp:revision>5</cp:revision>
  <dcterms:created xsi:type="dcterms:W3CDTF">2023-07-28T04:22:38Z</dcterms:created>
  <dcterms:modified xsi:type="dcterms:W3CDTF">2024-01-30T09:32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62AFD4EA7B58C4CB01E4592B9199AF4</vt:lpwstr>
  </property>
</Properties>
</file>